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7091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B7195A-55CF-4132-A618-95CF798BEA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84F62-EDE8-4EB6-853A-801D47B972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BCC8A-F665-497B-AD09-611C40B641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83D4C-CD14-4CF2-8CE0-639745191E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412F25-39D4-42C5-8586-3C2EFB0AD3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7C3EE4-B0CD-44A8-9CF4-245BE56A42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B93DD3-C2C9-453B-AAF0-BAF72C8FDB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8867A-28BB-478A-A7A4-35573D2758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4B61E-3AFB-48A5-86BA-43BFDC8D29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E34AB-7C9C-49F3-91BB-36F24BE529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AFFB1-63C9-44EB-87B3-838423E31E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B64FE-31A7-400F-95DB-724520D8FE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ca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a-E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ca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a-E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ca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321A4E-4AD3-469B-B375-FF437F917F3F}" type="slidenum">
              <a:rPr b="0" lang="ca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18880" y="1424160"/>
            <a:ext cx="6319080" cy="3817080"/>
            <a:chOff x="218880" y="1424160"/>
            <a:chExt cx="6319080" cy="3817080"/>
          </a:xfrm>
        </p:grpSpPr>
        <p:grpSp>
          <p:nvGrpSpPr>
            <p:cNvPr id="42" name=""/>
            <p:cNvGrpSpPr/>
            <p:nvPr/>
          </p:nvGrpSpPr>
          <p:grpSpPr>
            <a:xfrm>
              <a:off x="5445000" y="5076720"/>
              <a:ext cx="546120" cy="150840"/>
              <a:chOff x="5445000" y="5076720"/>
              <a:chExt cx="546120" cy="150840"/>
            </a:xfrm>
          </p:grpSpPr>
          <p:sp>
            <p:nvSpPr>
              <p:cNvPr id="43" name=""/>
              <p:cNvSpPr/>
              <p:nvPr/>
            </p:nvSpPr>
            <p:spPr>
              <a:xfrm>
                <a:off x="5445000" y="5226120"/>
                <a:ext cx="5461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5630760" y="50767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5" name=""/>
            <p:cNvSpPr/>
            <p:nvPr/>
          </p:nvSpPr>
          <p:spPr>
            <a:xfrm flipH="1" flipV="1">
              <a:off x="2507760" y="4457880"/>
              <a:ext cx="514440" cy="139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062160" y="4532400"/>
              <a:ext cx="768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eucrenophil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H="1" flipV="1">
              <a:off x="2507760" y="4457880"/>
              <a:ext cx="490680" cy="44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019680" y="4840200"/>
              <a:ext cx="602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enchelei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flipH="1" flipV="1">
              <a:off x="2422440" y="4427640"/>
              <a:ext cx="85680" cy="30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flipH="1" flipV="1">
              <a:off x="2471760" y="4619160"/>
              <a:ext cx="301680" cy="514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769840" y="5103720"/>
              <a:ext cx="759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molluscoru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V="1">
              <a:off x="2465280" y="4619520"/>
              <a:ext cx="6480" cy="285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318760" y="4873680"/>
              <a:ext cx="442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cavia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H="1" flipV="1">
              <a:off x="2422080" y="4427280"/>
              <a:ext cx="49320" cy="191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335680" y="45655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H="1" flipV="1">
              <a:off x="2306520" y="4335480"/>
              <a:ext cx="115920" cy="9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14880" y="43052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2200320" y="4514400"/>
              <a:ext cx="6480" cy="57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624680" y="5070600"/>
              <a:ext cx="999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hyd.anaerogene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1908000" y="4514760"/>
              <a:ext cx="298800" cy="424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405800" y="4923000"/>
              <a:ext cx="588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bivalviu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2206800" y="4335480"/>
              <a:ext cx="99720" cy="179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975320" y="44276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4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H="1" flipV="1">
              <a:off x="2243160" y="4185720"/>
              <a:ext cx="63360" cy="149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267640" y="40957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1312920" y="4255560"/>
              <a:ext cx="490320" cy="61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862920" y="4863960"/>
              <a:ext cx="480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popoffi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888840" y="4165200"/>
              <a:ext cx="658800" cy="149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36320" y="4255920"/>
              <a:ext cx="423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sobri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901800" y="3497400"/>
              <a:ext cx="645840" cy="668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18880" y="3367080"/>
              <a:ext cx="1000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allosaccharophil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547640" y="4165560"/>
              <a:ext cx="255600" cy="9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405440" y="41860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8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1803240" y="4186080"/>
              <a:ext cx="439920" cy="6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768680" y="41241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H="1" flipV="1">
              <a:off x="2163240" y="3841920"/>
              <a:ext cx="79560" cy="344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219760" y="38178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7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746360" y="3354480"/>
              <a:ext cx="347400" cy="40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182600" y="3200400"/>
              <a:ext cx="842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ca-ES" sz="900" spc="-1" strike="noStrike">
                  <a:solidFill>
                    <a:srgbClr val="000000"/>
                  </a:solidFill>
                  <a:latin typeface="Arial"/>
                </a:rPr>
                <a:t>A.punctata fla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057400" y="2982960"/>
              <a:ext cx="36360" cy="776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848960" y="2835360"/>
              <a:ext cx="715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ca-ES" sz="900" spc="-1" strike="noStrike">
                  <a:solidFill>
                    <a:srgbClr val="000000"/>
                  </a:solidFill>
                  <a:latin typeface="Arial"/>
                </a:rPr>
                <a:t>A.caviae fla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093760" y="3759120"/>
              <a:ext cx="69840" cy="82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110320" y="3654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5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456000" y="1824120"/>
              <a:ext cx="676440" cy="411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950560" y="1722600"/>
              <a:ext cx="480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jandae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046400" y="1584360"/>
              <a:ext cx="36720" cy="39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418920" y="1449360"/>
              <a:ext cx="633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ver.</a:t>
              </a:r>
              <a:r>
                <a:rPr b="0" lang="ca-ES" sz="900" spc="-1" strike="noStrike">
                  <a:solidFill>
                    <a:srgbClr val="000000"/>
                  </a:solidFill>
                  <a:latin typeface="Arial"/>
                </a:rPr>
                <a:t>Sobri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H="1">
              <a:off x="4083120" y="1565280"/>
              <a:ext cx="33120" cy="58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122720" y="1424160"/>
              <a:ext cx="578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culicicol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083120" y="1623960"/>
              <a:ext cx="49320" cy="61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894840" y="16048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132440" y="2235240"/>
              <a:ext cx="301320" cy="183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920040" y="2220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9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672080" y="1770120"/>
              <a:ext cx="3240" cy="331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335120" y="1635120"/>
              <a:ext cx="613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bestiaru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H="1">
              <a:off x="4957920" y="1744560"/>
              <a:ext cx="64800" cy="247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021280" y="1601640"/>
              <a:ext cx="924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sal.pectinolytic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H="1">
              <a:off x="4957920" y="1919160"/>
              <a:ext cx="426960" cy="7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407920" y="1832040"/>
              <a:ext cx="896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sal.salmonici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H="1">
              <a:off x="4674960" y="1992240"/>
              <a:ext cx="282600" cy="109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844160" y="22287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7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H="1">
              <a:off x="4645080" y="2101680"/>
              <a:ext cx="30240" cy="155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433040" y="20224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9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H="1">
              <a:off x="4966920" y="2333520"/>
              <a:ext cx="10332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090040" y="2200320"/>
              <a:ext cx="846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hyd.dhakensi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H="1">
              <a:off x="5006880" y="2413080"/>
              <a:ext cx="201600" cy="20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228280" y="2344680"/>
              <a:ext cx="621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hyd.rana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H="1" flipV="1">
              <a:off x="5006520" y="2433600"/>
              <a:ext cx="676440" cy="588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679360" y="2987640"/>
              <a:ext cx="858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ca-ES" sz="900" spc="-1" strike="noStrike">
                  <a:solidFill>
                    <a:srgbClr val="000000"/>
                  </a:solidFill>
                  <a:latin typeface="Arial"/>
                </a:rPr>
                <a:t>A.hyd.hydrophil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H="1" flipV="1">
              <a:off x="4967280" y="2366640"/>
              <a:ext cx="39600" cy="6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H="1" flipV="1">
              <a:off x="4644720" y="2257560"/>
              <a:ext cx="322200" cy="109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759920" y="18939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6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H="1">
              <a:off x="4433400" y="2257560"/>
              <a:ext cx="211320" cy="161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433040" y="2171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H="1">
              <a:off x="4340160" y="2419200"/>
              <a:ext cx="93600" cy="712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469040" y="2392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H="1" flipV="1">
              <a:off x="4533840" y="3668760"/>
              <a:ext cx="519120" cy="264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043960" y="3905280"/>
              <a:ext cx="11865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ca-ES" sz="900" spc="-1" strike="noStrike">
                  <a:solidFill>
                    <a:srgbClr val="000000"/>
                  </a:solidFill>
                  <a:latin typeface="Arial"/>
                </a:rPr>
                <a:t>A.hyd.hydrophila fla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559400" y="3875040"/>
              <a:ext cx="14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559400" y="3875040"/>
              <a:ext cx="14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515760" y="3898800"/>
              <a:ext cx="1220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ca-ES" sz="900" spc="-1" strike="noStrike">
                  <a:solidFill>
                    <a:srgbClr val="000000"/>
                  </a:solidFill>
                  <a:latin typeface="Arial"/>
                </a:rPr>
                <a:t>A.sal.salmonicida fla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H="1" flipV="1">
              <a:off x="4533480" y="3668400"/>
              <a:ext cx="25560" cy="206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534560" y="35496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flipH="1" flipV="1">
              <a:off x="4340160" y="3131640"/>
              <a:ext cx="193680" cy="536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383720" y="30607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8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flipH="1">
              <a:off x="2163600" y="3132000"/>
              <a:ext cx="2176560" cy="709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9T09:51:22Z</dcterms:created>
  <dc:creator>Maricarmen Fusté</dc:creator>
  <dc:description/>
  <dc:language>en-US</dc:language>
  <cp:lastModifiedBy>Ub</cp:lastModifiedBy>
  <dcterms:modified xsi:type="dcterms:W3CDTF">2009-07-14T16:33:06Z</dcterms:modified>
  <cp:revision>6</cp:revision>
  <dc:subject/>
  <dc:title>Diapositiva 1</dc:title>
</cp:coreProperties>
</file>